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53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F274CB4-79F7-E4B4-B40F-1C74301BF290}" name="Zhao, Yingdong (NIH/NCI) [E]" initials="YZ" userId="S::zhaoy@nih.gov::2b350bf9-507c-43f9-97f5-6b3e69eebc5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120" d="100"/>
          <a:sy n="120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AC688E-3BD8-B64C-BA1F-C4585303A05C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535EB1-28C1-D142-B785-D4D72B4F67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3492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6E68D-8EE2-BCC4-4C9A-72FC89CCD6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BA5BD87-F8FF-3077-4F9B-95FB51BD29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5386FD-50FF-AC47-8497-200288BFB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7652-ECFE-AE44-A842-1527CE835F9C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301955-E2C8-D15A-6856-57D0B798EA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3A8286-713E-22F6-06D6-0E8619EC2B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F928A-635E-4F4A-A650-3FE0F0B50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260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CDB040-B10A-0BEE-7C2E-530A6E326E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7E314E-7993-4943-9023-3891C3EF7C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333027-A8A4-52D6-E262-0640B068E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7652-ECFE-AE44-A842-1527CE835F9C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D47D93-9DCC-F144-7CCC-751E03849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31C08E-6E5B-5E61-2D2D-95397A404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F928A-635E-4F4A-A650-3FE0F0B50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048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E4B0E60-C26E-BE00-30A7-65AC5A3415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2AEEB1-E3E7-1109-7834-BAFEFCF42D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EF1AF1-7A81-6EAC-E3DB-44628DF55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7652-ECFE-AE44-A842-1527CE835F9C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454195-EF73-6CDF-9F48-AFC92E8FE9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8C66F8-6979-8697-D908-DB83B3FAE0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F928A-635E-4F4A-A650-3FE0F0B50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360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916735-B1C8-F1EB-1D5C-21FB4C1F67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3BF463-7469-D292-A425-9E6E4A86B5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C04B3B-21FC-6590-F30D-C176BAD08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7652-ECFE-AE44-A842-1527CE835F9C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96AEAC-1680-49EF-D990-8D84158C6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057B72-2EC0-6CFD-C76E-2C8521F42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F928A-635E-4F4A-A650-3FE0F0B50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477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C0953F-38C0-9D9F-6DD2-E031E7266E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694E51-5AAF-EC6C-8C76-373ACE78C5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EAD775-D7EE-523C-2CC9-94F7A39382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7652-ECFE-AE44-A842-1527CE835F9C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6B24A2-F07E-8125-4600-9C1807DB5C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04BFFA-C926-5F63-0B5D-B61AFE2456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F928A-635E-4F4A-A650-3FE0F0B50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524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D04018-D299-95DD-8003-C9B5609590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04646D-932E-0987-701C-B1674F8647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59AF2C-E893-3205-1831-8328090650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C9778D-D233-7836-4FF3-21AFBC577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7652-ECFE-AE44-A842-1527CE835F9C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5C750D-2E79-DA04-180D-4D1BC4F6D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93665A-DE0F-A119-545F-FA82543DE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F928A-635E-4F4A-A650-3FE0F0B50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2043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FE66EE-CFC1-2CC0-EBAB-AA57922FD9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3FA2CB-E834-D027-C43F-9332AE9571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C00F2F-67A5-E28D-687C-D47AA14749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B8C3377-CCB9-E50E-9783-E63E8BBB83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D18FC3-6581-55E0-1C28-315CAD89A4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381B21B-B889-76E9-EC8C-D5D3DFF96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7652-ECFE-AE44-A842-1527CE835F9C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4CDE3D0-AF38-8366-F9AA-BA0EC93EB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1D571B-2ED5-16DB-77F4-D8020B46B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F928A-635E-4F4A-A650-3FE0F0B50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454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DD13EA-99E8-9EA2-5616-EAA5BC390F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5E6FD24-98AB-B3AB-3C17-E64414DD4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7652-ECFE-AE44-A842-1527CE835F9C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FDD1F5-1A62-0C07-3A57-193ECE1F1B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4479285-163F-A5C7-22E7-4A3B3AC32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F928A-635E-4F4A-A650-3FE0F0B50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176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BB31FA4-C3E3-1F1C-D030-0888CC9301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7652-ECFE-AE44-A842-1527CE835F9C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791080A-50B7-9C1A-6D43-D5905A641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F396550-54FD-4FC8-6A10-9D37B96163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F928A-635E-4F4A-A650-3FE0F0B50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087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16BF7E-FFAD-ED72-96FD-2EEAF76A41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961C7B-1A36-AF1A-4E63-EDAAC60E3D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74413A-AC5B-7D4B-F4FD-1261C52D48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5AA6B0-2F22-F27F-586D-AAF67DF07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7652-ECFE-AE44-A842-1527CE835F9C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71892D-0B33-EDB6-8C25-9FF062F018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6B7392-357D-FEC2-046B-49FBF78F6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F928A-635E-4F4A-A650-3FE0F0B50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688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F385F2-F9EB-4004-F0F6-55000E8B19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900A06E-5709-CA72-0716-8958EB32E8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C3C77B-225D-5A17-042B-EB74F3E4B5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AEFBE9-71B2-F32B-D288-9542990BA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47652-ECFE-AE44-A842-1527CE835F9C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49F1E4-03E6-91FD-7C19-FA3FD6588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B5DA69-172B-9059-5A1D-8C3CA3612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F928A-635E-4F4A-A650-3FE0F0B50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053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DE9099D-B2A2-0D1D-1C54-A003F17645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8DA2EC-83FB-2CAC-E363-4962E37972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27919A-CC33-9499-7ABE-A69FFA5EBB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DB47652-ECFE-AE44-A842-1527CE835F9C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A5FACE-107D-CE67-FE7A-65D6AF69EA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50A123-3EA5-4185-8DE6-DBE9475C84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A7F928A-635E-4F4A-A650-3FE0F0B50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964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1FF6942-AD78-0BFC-AB48-9502F6D346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7329" y="142948"/>
            <a:ext cx="10676237" cy="586575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AA5441F-4E0F-2835-C0F6-D66E6C56BC79}"/>
              </a:ext>
            </a:extLst>
          </p:cNvPr>
          <p:cNvSpPr txBox="1"/>
          <p:nvPr/>
        </p:nvSpPr>
        <p:spPr>
          <a:xfrm>
            <a:off x="765005" y="6093759"/>
            <a:ext cx="1090088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5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GMT status class comparison, differentially expressed compounds. </a:t>
            </a:r>
            <a:r>
              <a:rPr lang="en-US" sz="1200" b="1" dirty="0"/>
              <a:t>A.</a:t>
            </a:r>
            <a:r>
              <a:rPr lang="en-US" sz="1200" dirty="0"/>
              <a:t> MGMT status and outcome,  Overall survival  (left panel) and Progression free survival (right panel). MGMT status was statistically significant for both outcome measures. </a:t>
            </a:r>
            <a:r>
              <a:rPr lang="en-US" sz="1200" b="1" dirty="0"/>
              <a:t>B. </a:t>
            </a:r>
            <a:r>
              <a:rPr lang="en-US" sz="1200" dirty="0"/>
              <a:t>Metabolomic differences were observed between classes both pre CRT (9 compounds) and in alteration pre. vs. post CRT (12 compounds). Pre CRT signal is illustrated in (</a:t>
            </a:r>
            <a:r>
              <a:rPr lang="en-US" sz="1200" b="1" dirty="0"/>
              <a:t>C</a:t>
            </a:r>
            <a:r>
              <a:rPr lang="en-US" sz="1200" dirty="0"/>
              <a:t>) and alteration with CRT in (</a:t>
            </a:r>
            <a:r>
              <a:rPr lang="en-US" sz="1200" b="1" dirty="0"/>
              <a:t>D</a:t>
            </a:r>
            <a:r>
              <a:rPr lang="en-US" sz="1200" dirty="0"/>
              <a:t>). 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698079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89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rauze, Andra (NIH/NCI) [E]</dc:creator>
  <cp:lastModifiedBy>Krauze, Andra (NIH/NCI) [E]</cp:lastModifiedBy>
  <cp:revision>4</cp:revision>
  <dcterms:created xsi:type="dcterms:W3CDTF">2025-08-22T16:51:12Z</dcterms:created>
  <dcterms:modified xsi:type="dcterms:W3CDTF">2025-10-28T20:16:12Z</dcterms:modified>
</cp:coreProperties>
</file>